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256" r:id="rId2"/>
    <p:sldId id="257" r:id="rId3"/>
    <p:sldId id="258" r:id="rId4"/>
    <p:sldId id="259" r:id="rId5"/>
    <p:sldId id="263" r:id="rId6"/>
    <p:sldId id="261" r:id="rId7"/>
    <p:sldId id="262" r:id="rId8"/>
    <p:sldId id="264" r:id="rId9"/>
    <p:sldId id="271" r:id="rId10"/>
    <p:sldId id="269" r:id="rId11"/>
    <p:sldId id="270" r:id="rId12"/>
    <p:sldId id="265" r:id="rId13"/>
    <p:sldId id="267" r:id="rId14"/>
    <p:sldId id="268" r:id="rId15"/>
    <p:sldId id="272" r:id="rId16"/>
    <p:sldId id="274" r:id="rId17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>
        <p:scale>
          <a:sx n="78" d="100"/>
          <a:sy n="78" d="100"/>
        </p:scale>
        <p:origin x="1522" y="203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7DADAA-1C33-45E8-BF7B-C089F081B22D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2A0101-86C7-49FF-BC7D-5C6521A659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1626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DBA653-5455-479D-A194-8DEA8A92E152}" type="slidenum">
              <a:rPr lang="ko-KR" altLang="en-US" smtClean="0"/>
              <a:pPr/>
              <a:t>1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24378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5235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9041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884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0949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3166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6435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890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9674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9146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8654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482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B395C-6008-4A77-872D-F88462531BE6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A1723-03C8-41EB-B548-5B5C47F20E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7585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4.jpeg"/><Relationship Id="rId7" Type="http://schemas.openxmlformats.org/officeDocument/2006/relationships/image" Target="../media/image128.jpeg"/><Relationship Id="rId2" Type="http://schemas.openxmlformats.org/officeDocument/2006/relationships/image" Target="../media/image12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7.jpeg"/><Relationship Id="rId5" Type="http://schemas.openxmlformats.org/officeDocument/2006/relationships/image" Target="../media/image126.jpeg"/><Relationship Id="rId4" Type="http://schemas.openxmlformats.org/officeDocument/2006/relationships/image" Target="../media/image125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0.jpeg"/><Relationship Id="rId7" Type="http://schemas.openxmlformats.org/officeDocument/2006/relationships/image" Target="../media/image134.jpeg"/><Relationship Id="rId2" Type="http://schemas.openxmlformats.org/officeDocument/2006/relationships/image" Target="../media/image12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3.jpeg"/><Relationship Id="rId5" Type="http://schemas.openxmlformats.org/officeDocument/2006/relationships/image" Target="../media/image132.jpeg"/><Relationship Id="rId4" Type="http://schemas.openxmlformats.org/officeDocument/2006/relationships/image" Target="../media/image131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jpeg"/><Relationship Id="rId7" Type="http://schemas.openxmlformats.org/officeDocument/2006/relationships/image" Target="../media/image140.jpeg"/><Relationship Id="rId2" Type="http://schemas.openxmlformats.org/officeDocument/2006/relationships/image" Target="../media/image13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9.jpeg"/><Relationship Id="rId5" Type="http://schemas.openxmlformats.org/officeDocument/2006/relationships/image" Target="../media/image138.jpeg"/><Relationship Id="rId4" Type="http://schemas.openxmlformats.org/officeDocument/2006/relationships/image" Target="../media/image137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2.jpeg"/><Relationship Id="rId2" Type="http://schemas.openxmlformats.org/officeDocument/2006/relationships/image" Target="../media/image141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8.jpeg"/><Relationship Id="rId3" Type="http://schemas.openxmlformats.org/officeDocument/2006/relationships/image" Target="../media/image143.jpeg"/><Relationship Id="rId7" Type="http://schemas.openxmlformats.org/officeDocument/2006/relationships/image" Target="../media/image14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6.jpeg"/><Relationship Id="rId5" Type="http://schemas.openxmlformats.org/officeDocument/2006/relationships/image" Target="../media/image145.jpeg"/><Relationship Id="rId4" Type="http://schemas.openxmlformats.org/officeDocument/2006/relationships/image" Target="../media/image144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0.jpeg"/><Relationship Id="rId7" Type="http://schemas.openxmlformats.org/officeDocument/2006/relationships/image" Target="../media/image153.jpeg"/><Relationship Id="rId2" Type="http://schemas.openxmlformats.org/officeDocument/2006/relationships/image" Target="../media/image14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2.jpeg"/><Relationship Id="rId5" Type="http://schemas.openxmlformats.org/officeDocument/2006/relationships/image" Target="../media/image96.jpeg"/><Relationship Id="rId4" Type="http://schemas.openxmlformats.org/officeDocument/2006/relationships/image" Target="../media/image151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5.jpeg"/><Relationship Id="rId7" Type="http://schemas.openxmlformats.org/officeDocument/2006/relationships/image" Target="../media/image159.jpeg"/><Relationship Id="rId2" Type="http://schemas.openxmlformats.org/officeDocument/2006/relationships/image" Target="../media/image15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8.jpeg"/><Relationship Id="rId5" Type="http://schemas.openxmlformats.org/officeDocument/2006/relationships/image" Target="../media/image157.jpeg"/><Relationship Id="rId4" Type="http://schemas.openxmlformats.org/officeDocument/2006/relationships/image" Target="../media/image156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13" Type="http://schemas.openxmlformats.org/officeDocument/2006/relationships/image" Target="../media/image30.jpeg"/><Relationship Id="rId18" Type="http://schemas.openxmlformats.org/officeDocument/2006/relationships/image" Target="../media/image35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12" Type="http://schemas.openxmlformats.org/officeDocument/2006/relationships/image" Target="../media/image29.jpeg"/><Relationship Id="rId17" Type="http://schemas.openxmlformats.org/officeDocument/2006/relationships/image" Target="../media/image34.jpeg"/><Relationship Id="rId2" Type="http://schemas.openxmlformats.org/officeDocument/2006/relationships/image" Target="../media/image19.jpeg"/><Relationship Id="rId16" Type="http://schemas.openxmlformats.org/officeDocument/2006/relationships/image" Target="../media/image3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eg"/><Relationship Id="rId11" Type="http://schemas.openxmlformats.org/officeDocument/2006/relationships/image" Target="../media/image28.jpeg"/><Relationship Id="rId5" Type="http://schemas.openxmlformats.org/officeDocument/2006/relationships/image" Target="../media/image22.jpeg"/><Relationship Id="rId15" Type="http://schemas.openxmlformats.org/officeDocument/2006/relationships/image" Target="../media/image32.jpeg"/><Relationship Id="rId10" Type="http://schemas.openxmlformats.org/officeDocument/2006/relationships/image" Target="../media/image27.jpeg"/><Relationship Id="rId19" Type="http://schemas.openxmlformats.org/officeDocument/2006/relationships/image" Target="../media/image36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Relationship Id="rId14" Type="http://schemas.openxmlformats.org/officeDocument/2006/relationships/image" Target="../media/image3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eg"/><Relationship Id="rId13" Type="http://schemas.openxmlformats.org/officeDocument/2006/relationships/image" Target="../media/image48.jpeg"/><Relationship Id="rId18" Type="http://schemas.openxmlformats.org/officeDocument/2006/relationships/image" Target="../media/image53.jpeg"/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12" Type="http://schemas.openxmlformats.org/officeDocument/2006/relationships/image" Target="../media/image47.jpeg"/><Relationship Id="rId17" Type="http://schemas.openxmlformats.org/officeDocument/2006/relationships/image" Target="../media/image52.jpeg"/><Relationship Id="rId2" Type="http://schemas.openxmlformats.org/officeDocument/2006/relationships/image" Target="../media/image37.jpeg"/><Relationship Id="rId16" Type="http://schemas.openxmlformats.org/officeDocument/2006/relationships/image" Target="../media/image5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jpeg"/><Relationship Id="rId11" Type="http://schemas.openxmlformats.org/officeDocument/2006/relationships/image" Target="../media/image46.jpeg"/><Relationship Id="rId5" Type="http://schemas.openxmlformats.org/officeDocument/2006/relationships/image" Target="../media/image40.jpeg"/><Relationship Id="rId15" Type="http://schemas.openxmlformats.org/officeDocument/2006/relationships/image" Target="../media/image50.jpeg"/><Relationship Id="rId10" Type="http://schemas.openxmlformats.org/officeDocument/2006/relationships/image" Target="../media/image45.jpeg"/><Relationship Id="rId19" Type="http://schemas.openxmlformats.org/officeDocument/2006/relationships/image" Target="../media/image54.jpeg"/><Relationship Id="rId4" Type="http://schemas.openxmlformats.org/officeDocument/2006/relationships/image" Target="../media/image39.jpeg"/><Relationship Id="rId9" Type="http://schemas.openxmlformats.org/officeDocument/2006/relationships/image" Target="../media/image44.jpeg"/><Relationship Id="rId14" Type="http://schemas.openxmlformats.org/officeDocument/2006/relationships/image" Target="../media/image49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jpeg"/><Relationship Id="rId13" Type="http://schemas.openxmlformats.org/officeDocument/2006/relationships/image" Target="../media/image66.jpeg"/><Relationship Id="rId18" Type="http://schemas.openxmlformats.org/officeDocument/2006/relationships/image" Target="../media/image71.jpeg"/><Relationship Id="rId3" Type="http://schemas.openxmlformats.org/officeDocument/2006/relationships/image" Target="../media/image56.jpeg"/><Relationship Id="rId7" Type="http://schemas.openxmlformats.org/officeDocument/2006/relationships/image" Target="../media/image60.jpeg"/><Relationship Id="rId12" Type="http://schemas.openxmlformats.org/officeDocument/2006/relationships/image" Target="../media/image65.jpeg"/><Relationship Id="rId17" Type="http://schemas.openxmlformats.org/officeDocument/2006/relationships/image" Target="../media/image70.jpeg"/><Relationship Id="rId2" Type="http://schemas.openxmlformats.org/officeDocument/2006/relationships/image" Target="../media/image55.jpeg"/><Relationship Id="rId16" Type="http://schemas.openxmlformats.org/officeDocument/2006/relationships/image" Target="../media/image6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9.jpeg"/><Relationship Id="rId11" Type="http://schemas.openxmlformats.org/officeDocument/2006/relationships/image" Target="../media/image64.jpeg"/><Relationship Id="rId5" Type="http://schemas.openxmlformats.org/officeDocument/2006/relationships/image" Target="../media/image58.jpeg"/><Relationship Id="rId15" Type="http://schemas.openxmlformats.org/officeDocument/2006/relationships/image" Target="../media/image68.jpeg"/><Relationship Id="rId10" Type="http://schemas.openxmlformats.org/officeDocument/2006/relationships/image" Target="../media/image63.jpeg"/><Relationship Id="rId19" Type="http://schemas.openxmlformats.org/officeDocument/2006/relationships/image" Target="../media/image72.jpeg"/><Relationship Id="rId4" Type="http://schemas.openxmlformats.org/officeDocument/2006/relationships/image" Target="../media/image57.jpeg"/><Relationship Id="rId9" Type="http://schemas.openxmlformats.org/officeDocument/2006/relationships/image" Target="../media/image62.jpeg"/><Relationship Id="rId14" Type="http://schemas.openxmlformats.org/officeDocument/2006/relationships/image" Target="../media/image6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jpeg"/><Relationship Id="rId13" Type="http://schemas.openxmlformats.org/officeDocument/2006/relationships/image" Target="../media/image84.jpeg"/><Relationship Id="rId3" Type="http://schemas.openxmlformats.org/officeDocument/2006/relationships/image" Target="../media/image74.jpeg"/><Relationship Id="rId7" Type="http://schemas.openxmlformats.org/officeDocument/2006/relationships/image" Target="../media/image78.jpeg"/><Relationship Id="rId12" Type="http://schemas.openxmlformats.org/officeDocument/2006/relationships/image" Target="../media/image83.jpeg"/><Relationship Id="rId2" Type="http://schemas.openxmlformats.org/officeDocument/2006/relationships/image" Target="../media/image7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7.jpeg"/><Relationship Id="rId11" Type="http://schemas.openxmlformats.org/officeDocument/2006/relationships/image" Target="../media/image82.jpeg"/><Relationship Id="rId5" Type="http://schemas.openxmlformats.org/officeDocument/2006/relationships/image" Target="../media/image76.jpeg"/><Relationship Id="rId10" Type="http://schemas.openxmlformats.org/officeDocument/2006/relationships/image" Target="../media/image81.jpeg"/><Relationship Id="rId4" Type="http://schemas.openxmlformats.org/officeDocument/2006/relationships/image" Target="../media/image75.jpeg"/><Relationship Id="rId9" Type="http://schemas.openxmlformats.org/officeDocument/2006/relationships/image" Target="../media/image8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jpeg"/><Relationship Id="rId13" Type="http://schemas.microsoft.com/office/2007/relationships/hdphoto" Target="../media/hdphoto1.wdp"/><Relationship Id="rId3" Type="http://schemas.openxmlformats.org/officeDocument/2006/relationships/image" Target="../media/image86.jpeg"/><Relationship Id="rId7" Type="http://schemas.openxmlformats.org/officeDocument/2006/relationships/image" Target="../media/image90.jpeg"/><Relationship Id="rId12" Type="http://schemas.openxmlformats.org/officeDocument/2006/relationships/image" Target="../media/image95.jpeg"/><Relationship Id="rId2" Type="http://schemas.openxmlformats.org/officeDocument/2006/relationships/image" Target="../media/image8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9.jpeg"/><Relationship Id="rId11" Type="http://schemas.openxmlformats.org/officeDocument/2006/relationships/image" Target="../media/image94.jpeg"/><Relationship Id="rId5" Type="http://schemas.openxmlformats.org/officeDocument/2006/relationships/image" Target="../media/image88.jpeg"/><Relationship Id="rId10" Type="http://schemas.openxmlformats.org/officeDocument/2006/relationships/image" Target="../media/image93.jpeg"/><Relationship Id="rId4" Type="http://schemas.openxmlformats.org/officeDocument/2006/relationships/image" Target="../media/image87.jpeg"/><Relationship Id="rId9" Type="http://schemas.openxmlformats.org/officeDocument/2006/relationships/image" Target="../media/image92.jpeg"/><Relationship Id="rId14" Type="http://schemas.openxmlformats.org/officeDocument/2006/relationships/image" Target="../media/image96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jpeg"/><Relationship Id="rId13" Type="http://schemas.openxmlformats.org/officeDocument/2006/relationships/image" Target="../media/image108.jpeg"/><Relationship Id="rId3" Type="http://schemas.openxmlformats.org/officeDocument/2006/relationships/image" Target="../media/image98.jpeg"/><Relationship Id="rId7" Type="http://schemas.openxmlformats.org/officeDocument/2006/relationships/image" Target="../media/image102.jpeg"/><Relationship Id="rId12" Type="http://schemas.openxmlformats.org/officeDocument/2006/relationships/image" Target="../media/image107.jpeg"/><Relationship Id="rId2" Type="http://schemas.openxmlformats.org/officeDocument/2006/relationships/image" Target="../media/image9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1.jpeg"/><Relationship Id="rId11" Type="http://schemas.openxmlformats.org/officeDocument/2006/relationships/image" Target="../media/image106.jpeg"/><Relationship Id="rId5" Type="http://schemas.openxmlformats.org/officeDocument/2006/relationships/image" Target="../media/image100.jpeg"/><Relationship Id="rId10" Type="http://schemas.openxmlformats.org/officeDocument/2006/relationships/image" Target="../media/image105.jpeg"/><Relationship Id="rId4" Type="http://schemas.openxmlformats.org/officeDocument/2006/relationships/image" Target="../media/image99.jpeg"/><Relationship Id="rId9" Type="http://schemas.openxmlformats.org/officeDocument/2006/relationships/image" Target="../media/image104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5.jpeg"/><Relationship Id="rId13" Type="http://schemas.openxmlformats.org/officeDocument/2006/relationships/image" Target="../media/image120.jpeg"/><Relationship Id="rId3" Type="http://schemas.openxmlformats.org/officeDocument/2006/relationships/image" Target="../media/image110.jpeg"/><Relationship Id="rId7" Type="http://schemas.openxmlformats.org/officeDocument/2006/relationships/image" Target="../media/image114.jpeg"/><Relationship Id="rId12" Type="http://schemas.openxmlformats.org/officeDocument/2006/relationships/image" Target="../media/image119.jpeg"/><Relationship Id="rId2" Type="http://schemas.openxmlformats.org/officeDocument/2006/relationships/image" Target="../media/image10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3.jpeg"/><Relationship Id="rId11" Type="http://schemas.openxmlformats.org/officeDocument/2006/relationships/image" Target="../media/image118.jpeg"/><Relationship Id="rId5" Type="http://schemas.openxmlformats.org/officeDocument/2006/relationships/image" Target="../media/image112.jpeg"/><Relationship Id="rId10" Type="http://schemas.openxmlformats.org/officeDocument/2006/relationships/image" Target="../media/image117.jpeg"/><Relationship Id="rId4" Type="http://schemas.openxmlformats.org/officeDocument/2006/relationships/image" Target="../media/image111.jpeg"/><Relationship Id="rId9" Type="http://schemas.openxmlformats.org/officeDocument/2006/relationships/image" Target="../media/image116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2.jpeg"/><Relationship Id="rId2" Type="http://schemas.openxmlformats.org/officeDocument/2006/relationships/image" Target="../media/image12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F:\13.01.09 ID3-rH2AX.mdb\8hr-U2OS-siCTL-rH2AX-4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9997" y="98265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F:\13.01.09 ID3-rH2AX.mdb\8hr-U2OS-siCTL-rH2AX-4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9997" y="458305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F:\13.01.09 ID3-rH2AX.mdb\8hr-U2OS-siCTL-rH2AX-4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9997" y="279827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F:\13.01.09 ID3-rH2AX.mdb\8hr-U2OS-siCTL-rH2AX-5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7829" y="97695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F:\13.01.09 ID3-rH2AX.mdb\8hr-U2OS-siCTL-rH2AX-5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7829" y="457042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F:\13.01.09 ID3-rH2AX.mdb\8hr-U2OS-siCTL-rH2AX-5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7829" y="278386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F:\13.01.09 ID3-rH2AX.mdb\8hr-U2OS-siCTL-rH2AX-6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5661" y="97695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F:\13.01.09 ID3-rH2AX.mdb\8hr-U2OS-siCTL-rH2AX-6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5661" y="457042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F:\13.01.09 ID3-rH2AX.mdb\8hr-U2OS-siCTL-rH2AX-6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5661" y="278564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F:\13.01.09 ID3-rH2AX.mdb\8hr-U2OS-siCTL-rH2AX-1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0079" y="98072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F:\13.01.09 ID3-rH2AX.mdb\8hr-U2OS-siCTL-rH2AX-1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1672" y="457042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F:\13.01.09 ID3-rH2AX.mdb\8hr-U2OS-siCTL-rH2AX-1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0876" y="276821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F:\13.01.09 ID3-rH2AX.mdb\8hr-U2OS-siCTL-rH2AX-2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3324" y="98072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F:\13.01.09 ID3-rH2AX.mdb\8hr-U2OS-siCTL-rH2AX-2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3324" y="458112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F:\13.01.09 ID3-rH2AX.mdb\8hr-U2OS-siCTL-rH2AX-2_c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3324" y="278092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F:\13.01.09 ID3-rH2AX.mdb\8hr-U2OS-siCTL-rH2AX-3_c1+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56" y="458112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 descr="F:\13.01.09 ID3-rH2AX.mdb\8hr-U2OS-siCTL-rH2AX-3_c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01" y="277891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F:\13.01.09 ID3-rH2AX.mdb\8hr-U2OS-siCTL-rH2AX-3_c1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01" y="98836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51520" y="219998"/>
            <a:ext cx="35094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8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0937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7" name="Picture 5" descr="C:\Users\hahahamj\Desktop\새홀리기\rH2AX\U2OSsiCTL-MDC1rH2AX-30min-2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51398" y="1340768"/>
            <a:ext cx="2160000" cy="2160000"/>
          </a:xfrm>
          <a:prstGeom prst="rect">
            <a:avLst/>
          </a:prstGeom>
          <a:noFill/>
        </p:spPr>
      </p:pic>
      <p:pic>
        <p:nvPicPr>
          <p:cNvPr id="8203" name="Picture 11" descr="C:\Users\hahahamj\Desktop\새홀리기\rH2AX\U2OSsiCTL-MDC1rH2AX-1hr-2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83646" y="1340768"/>
            <a:ext cx="2160000" cy="2160000"/>
          </a:xfrm>
          <a:prstGeom prst="rect">
            <a:avLst/>
          </a:prstGeom>
          <a:noFill/>
        </p:spPr>
      </p:pic>
      <p:pic>
        <p:nvPicPr>
          <p:cNvPr id="8219" name="Picture 27" descr="C:\Users\hahahamj\Desktop\새홀리기\rH2AX\U2OSsiCTL-MDC1rH2AX-3hr-1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415894" y="1340768"/>
            <a:ext cx="2160000" cy="2160000"/>
          </a:xfrm>
          <a:prstGeom prst="rect">
            <a:avLst/>
          </a:prstGeom>
          <a:noFill/>
        </p:spPr>
      </p:pic>
      <p:sp>
        <p:nvSpPr>
          <p:cNvPr id="28" name="TextBox 27"/>
          <p:cNvSpPr txBox="1"/>
          <p:nvPr/>
        </p:nvSpPr>
        <p:spPr>
          <a:xfrm>
            <a:off x="3273373" y="257430"/>
            <a:ext cx="39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     IR 30 min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8" descr="C:\Users\hahahamj\Desktop\새홀리기\DAPI\U2OSsiCTL-MDC1rH2AX-30min-2.jpg"/>
          <p:cNvPicPr>
            <a:picLocks noChangeAspect="1" noChangeArrowheads="1"/>
          </p:cNvPicPr>
          <p:nvPr/>
        </p:nvPicPr>
        <p:blipFill>
          <a:blip r:embed="rId5" cstate="print">
            <a:lum bright="-10000"/>
          </a:blip>
          <a:srcRect/>
          <a:stretch>
            <a:fillRect/>
          </a:stretch>
        </p:blipFill>
        <p:spPr bwMode="auto">
          <a:xfrm>
            <a:off x="1951638" y="3645024"/>
            <a:ext cx="2160000" cy="2160000"/>
          </a:xfrm>
          <a:prstGeom prst="rect">
            <a:avLst/>
          </a:prstGeom>
          <a:noFill/>
        </p:spPr>
      </p:pic>
      <p:pic>
        <p:nvPicPr>
          <p:cNvPr id="16" name="Picture 14" descr="C:\Users\hahahamj\Desktop\새홀리기\DAPI\U2OSsiCTL-MDC1rH2AX-1hr-2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183886" y="3645024"/>
            <a:ext cx="2160000" cy="2160000"/>
          </a:xfrm>
          <a:prstGeom prst="rect">
            <a:avLst/>
          </a:prstGeom>
          <a:noFill/>
        </p:spPr>
      </p:pic>
      <p:pic>
        <p:nvPicPr>
          <p:cNvPr id="18" name="Picture 23" descr="C:\Users\hahahamj\Desktop\새홀리기\DAPI\U2OSsiCTL-MDC1rH2AX-3hr-1.jpg"/>
          <p:cNvPicPr>
            <a:picLocks noChangeAspect="1" noChangeArrowheads="1"/>
          </p:cNvPicPr>
          <p:nvPr/>
        </p:nvPicPr>
        <p:blipFill>
          <a:blip r:embed="rId7" cstate="print">
            <a:lum bright="-10000"/>
          </a:blip>
          <a:srcRect/>
          <a:stretch>
            <a:fillRect/>
          </a:stretch>
        </p:blipFill>
        <p:spPr bwMode="auto">
          <a:xfrm>
            <a:off x="6444448" y="3645264"/>
            <a:ext cx="2160000" cy="21600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3954105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6" name="Picture 12" descr="C:\Users\hahahamj\Desktop\새홀리기\DAPI\U2OSsiCTL-MDC1rH2AX-30min-1.jpg"/>
          <p:cNvPicPr>
            <a:picLocks noChangeAspect="1" noChangeArrowheads="1"/>
          </p:cNvPicPr>
          <p:nvPr/>
        </p:nvPicPr>
        <p:blipFill>
          <a:blip r:embed="rId2" cstate="print">
            <a:lum bright="-10000"/>
          </a:blip>
          <a:srcRect/>
          <a:stretch>
            <a:fillRect/>
          </a:stretch>
        </p:blipFill>
        <p:spPr bwMode="auto">
          <a:xfrm>
            <a:off x="1763688" y="3717032"/>
            <a:ext cx="2160000" cy="2160000"/>
          </a:xfrm>
          <a:prstGeom prst="rect">
            <a:avLst/>
          </a:prstGeom>
          <a:noFill/>
        </p:spPr>
      </p:pic>
      <p:pic>
        <p:nvPicPr>
          <p:cNvPr id="1042" name="Picture 18" descr="C:\Users\hahahamj\Desktop\새홀리기\DAPI\U2OSsiCTL-MDC1rH2AX-1hr-1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95936" y="3717032"/>
            <a:ext cx="2160000" cy="2160000"/>
          </a:xfrm>
          <a:prstGeom prst="rect">
            <a:avLst/>
          </a:prstGeom>
          <a:noFill/>
        </p:spPr>
      </p:pic>
      <p:sp>
        <p:nvSpPr>
          <p:cNvPr id="13" name="직사각형 12"/>
          <p:cNvSpPr/>
          <p:nvPr/>
        </p:nvSpPr>
        <p:spPr>
          <a:xfrm>
            <a:off x="1619672" y="1304644"/>
            <a:ext cx="2340140" cy="47166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5" name="Picture 9" descr="C:\Users\hahahamj\Desktop\새홀리기\rH2AX\U2OSsiCTL-MDC1rH2AX-30min-1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763688" y="1484784"/>
            <a:ext cx="2160000" cy="2160000"/>
          </a:xfrm>
          <a:prstGeom prst="rect">
            <a:avLst/>
          </a:prstGeom>
          <a:noFill/>
        </p:spPr>
      </p:pic>
      <p:pic>
        <p:nvPicPr>
          <p:cNvPr id="16" name="Picture 15" descr="C:\Users\hahahamj\Desktop\새홀리기\rH2AX\U2OSsiCTL-MDC1rH2AX-1hr-1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995936" y="1484784"/>
            <a:ext cx="2160000" cy="2160000"/>
          </a:xfrm>
          <a:prstGeom prst="rect">
            <a:avLst/>
          </a:prstGeom>
          <a:noFill/>
        </p:spPr>
      </p:pic>
      <p:pic>
        <p:nvPicPr>
          <p:cNvPr id="17" name="Picture 23" descr="C:\Users\hahahamj\Desktop\새홀리기\rH2AX\U2OSsiCTL-MDC1rH2AX-3hr-2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228184" y="1484784"/>
            <a:ext cx="2160000" cy="2160000"/>
          </a:xfrm>
          <a:prstGeom prst="rect">
            <a:avLst/>
          </a:prstGeom>
          <a:noFill/>
        </p:spPr>
      </p:pic>
      <p:sp>
        <p:nvSpPr>
          <p:cNvPr id="18" name="TextBox 17"/>
          <p:cNvSpPr txBox="1"/>
          <p:nvPr/>
        </p:nvSpPr>
        <p:spPr>
          <a:xfrm>
            <a:off x="3059832" y="273422"/>
            <a:ext cx="39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     IR 30 min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19" descr="C:\Users\hahahamj\Desktop\새홀리기\DAPI\U2OSsiCTL-MDC1rH2AX-3hr-2.jpg"/>
          <p:cNvPicPr>
            <a:picLocks noChangeAspect="1" noChangeArrowheads="1"/>
          </p:cNvPicPr>
          <p:nvPr/>
        </p:nvPicPr>
        <p:blipFill>
          <a:blip r:embed="rId7" cstate="print">
            <a:lum bright="-10000"/>
          </a:blip>
          <a:srcRect/>
          <a:stretch>
            <a:fillRect/>
          </a:stretch>
        </p:blipFill>
        <p:spPr bwMode="auto">
          <a:xfrm>
            <a:off x="6228424" y="3717032"/>
            <a:ext cx="2160000" cy="21600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1009293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1" descr="C:\Users\hahahamj\Desktop\새홀리기\DAPI\U2OSsiCTL-MDC1rH2AX-30min.jpg"/>
          <p:cNvPicPr>
            <a:picLocks noChangeAspect="1" noChangeArrowheads="1"/>
          </p:cNvPicPr>
          <p:nvPr/>
        </p:nvPicPr>
        <p:blipFill>
          <a:blip r:embed="rId2" cstate="print">
            <a:lum bright="-10000"/>
          </a:blip>
          <a:srcRect/>
          <a:stretch>
            <a:fillRect/>
          </a:stretch>
        </p:blipFill>
        <p:spPr bwMode="auto">
          <a:xfrm>
            <a:off x="1403408" y="3645024"/>
            <a:ext cx="2160000" cy="2160000"/>
          </a:xfrm>
          <a:prstGeom prst="rect">
            <a:avLst/>
          </a:prstGeom>
          <a:noFill/>
        </p:spPr>
      </p:pic>
      <p:pic>
        <p:nvPicPr>
          <p:cNvPr id="16" name="Picture 17" descr="C:\Users\hahahamj\Desktop\새홀리기\DAPI\U2OSsiCTL-MDC1rH2AX-1hr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35656" y="3645024"/>
            <a:ext cx="2160000" cy="2160000"/>
          </a:xfrm>
          <a:prstGeom prst="rect">
            <a:avLst/>
          </a:prstGeom>
          <a:noFill/>
        </p:spPr>
      </p:pic>
      <p:pic>
        <p:nvPicPr>
          <p:cNvPr id="18" name="Picture 8" descr="C:\Users\hahahamj\Desktop\새홀리기\rH2AX\U2OSsiCTL-MDC1rH2AX-30min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03648" y="1412776"/>
            <a:ext cx="2160000" cy="2160000"/>
          </a:xfrm>
          <a:prstGeom prst="rect">
            <a:avLst/>
          </a:prstGeom>
          <a:noFill/>
        </p:spPr>
      </p:pic>
      <p:pic>
        <p:nvPicPr>
          <p:cNvPr id="19" name="Picture 14" descr="C:\Users\hahahamj\Desktop\새홀리기\rH2AX\U2OSsiCTL-MDC1rH2AX-1hr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635896" y="1412776"/>
            <a:ext cx="2160000" cy="2160000"/>
          </a:xfrm>
          <a:prstGeom prst="rect">
            <a:avLst/>
          </a:prstGeom>
          <a:noFill/>
        </p:spPr>
      </p:pic>
      <p:pic>
        <p:nvPicPr>
          <p:cNvPr id="20" name="Picture 26" descr="C:\Users\hahahamj\Desktop\새홀리기\rH2AX\U2OSsiCTL-MDC1rH2AX-3hr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868144" y="1412776"/>
            <a:ext cx="2160000" cy="2160000"/>
          </a:xfrm>
          <a:prstGeom prst="rect">
            <a:avLst/>
          </a:prstGeom>
          <a:noFill/>
        </p:spPr>
      </p:pic>
      <p:sp>
        <p:nvSpPr>
          <p:cNvPr id="21" name="TextBox 20"/>
          <p:cNvSpPr txBox="1"/>
          <p:nvPr/>
        </p:nvSpPr>
        <p:spPr>
          <a:xfrm>
            <a:off x="2843808" y="273422"/>
            <a:ext cx="39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     IR 30 min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2" descr="C:\Users\hahahamj\Desktop\새홀리기\DAPI\U2OSsiCTL-MDC1rH2AX-3hr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868144" y="3645024"/>
            <a:ext cx="2160000" cy="21600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5820119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2" descr="C:\Users\hahahamj\Desktop\새홀리기\rH2AX\U2OSmiR_let7a-MDC1rH2AX-0hr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35896" y="1341008"/>
            <a:ext cx="2160000" cy="2160000"/>
          </a:xfrm>
          <a:prstGeom prst="rect">
            <a:avLst/>
          </a:prstGeom>
          <a:noFill/>
        </p:spPr>
      </p:pic>
      <p:pic>
        <p:nvPicPr>
          <p:cNvPr id="16" name="Picture 3" descr="C:\Users\hahahamj\Desktop\새홀리기\DAPI\U2OSmiR_let7a-MDC1rH2AX-0hr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35896" y="3573016"/>
            <a:ext cx="2160000" cy="2160000"/>
          </a:xfrm>
          <a:prstGeom prst="rect">
            <a:avLst/>
          </a:prstGeom>
          <a:noFill/>
        </p:spPr>
      </p:pic>
      <p:sp>
        <p:nvSpPr>
          <p:cNvPr id="17" name="TextBox 16"/>
          <p:cNvSpPr txBox="1"/>
          <p:nvPr/>
        </p:nvSpPr>
        <p:spPr>
          <a:xfrm>
            <a:off x="3707904" y="345670"/>
            <a:ext cx="27587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iID3    UT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3563888" y="1268760"/>
            <a:ext cx="2340140" cy="460851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669044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C:\Users\hahahamj\Desktop\새홀리기\DAPI\U2OSmiR_let7a-MDC1rH2AX-3hr-2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084493" y="3501248"/>
            <a:ext cx="2160000" cy="2160000"/>
          </a:xfrm>
          <a:prstGeom prst="rect">
            <a:avLst/>
          </a:prstGeom>
          <a:noFill/>
        </p:spPr>
      </p:pic>
      <p:pic>
        <p:nvPicPr>
          <p:cNvPr id="14" name="Picture 4" descr="C:\Users\hahahamj\Desktop\새홀리기\rH2AX\U2OSmiR_let7a-MDC1rH2AX-30min-1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19672" y="1269000"/>
            <a:ext cx="2160000" cy="2160000"/>
          </a:xfrm>
          <a:prstGeom prst="rect">
            <a:avLst/>
          </a:prstGeom>
          <a:noFill/>
        </p:spPr>
      </p:pic>
      <p:pic>
        <p:nvPicPr>
          <p:cNvPr id="16" name="Picture 10" descr="C:\Users\hahahamj\Desktop\새홀리기\rH2AX\U2OSmiR_let7a-MDC1rH2AX-1hr-2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851920" y="1269000"/>
            <a:ext cx="2160000" cy="2160000"/>
          </a:xfrm>
          <a:prstGeom prst="rect">
            <a:avLst/>
          </a:prstGeom>
          <a:noFill/>
        </p:spPr>
      </p:pic>
      <p:pic>
        <p:nvPicPr>
          <p:cNvPr id="17" name="Picture 16" descr="C:\Users\hahahamj\Desktop\새홀리기\rH2AX\U2OSmiR_let7a-MDC1rH2AX-3hr-2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084168" y="1269000"/>
            <a:ext cx="2160000" cy="2160000"/>
          </a:xfrm>
          <a:prstGeom prst="rect">
            <a:avLst/>
          </a:prstGeom>
          <a:noFill/>
        </p:spPr>
      </p:pic>
      <p:pic>
        <p:nvPicPr>
          <p:cNvPr id="22" name="Picture 6" descr="C:\Users\hahahamj\Desktop\새홀리기\DAPI\U2OSmiR_let7a-MDC1rH2AX-30min-1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619912" y="3501008"/>
            <a:ext cx="2160000" cy="2160000"/>
          </a:xfrm>
          <a:prstGeom prst="rect">
            <a:avLst/>
          </a:prstGeom>
          <a:noFill/>
        </p:spPr>
      </p:pic>
      <p:pic>
        <p:nvPicPr>
          <p:cNvPr id="26" name="Picture 8" descr="C:\Users\hahahamj\Desktop\새홀리기\DAPI\U2OSmiR_let7a-MDC1rH2AX-1hr-2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852160" y="3501008"/>
            <a:ext cx="2160000" cy="2160000"/>
          </a:xfrm>
          <a:prstGeom prst="rect">
            <a:avLst/>
          </a:prstGeom>
          <a:noFill/>
        </p:spPr>
      </p:pic>
      <p:sp>
        <p:nvSpPr>
          <p:cNvPr id="31" name="TextBox 30"/>
          <p:cNvSpPr txBox="1"/>
          <p:nvPr/>
        </p:nvSpPr>
        <p:spPr>
          <a:xfrm>
            <a:off x="3131840" y="188640"/>
            <a:ext cx="39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iID3     IR 30 min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415599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9" descr="C:\Users\hahahamj\Desktop\새홀리기\rH2AX\U2OSmiR_let7a-MDC1rH2AX-30min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86521" y="1681362"/>
            <a:ext cx="2160000" cy="2160000"/>
          </a:xfrm>
          <a:prstGeom prst="rect">
            <a:avLst/>
          </a:prstGeom>
          <a:noFill/>
        </p:spPr>
      </p:pic>
      <p:pic>
        <p:nvPicPr>
          <p:cNvPr id="9229" name="Picture 13" descr="C:\Users\hahahamj\Desktop\새홀리기\rH2AX\U2OSmiR_let7a-MDC1rH2AX-1hr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18769" y="1681362"/>
            <a:ext cx="2160000" cy="2160000"/>
          </a:xfrm>
          <a:prstGeom prst="rect">
            <a:avLst/>
          </a:prstGeom>
          <a:noFill/>
        </p:spPr>
      </p:pic>
      <p:pic>
        <p:nvPicPr>
          <p:cNvPr id="9235" name="Picture 19" descr="C:\Users\hahahamj\Desktop\새홀리기\rH2AX\U2OSmiR_let7a-MDC1rH2AX-3hr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51017" y="1681362"/>
            <a:ext cx="2160000" cy="2160000"/>
          </a:xfrm>
          <a:prstGeom prst="rect">
            <a:avLst/>
          </a:prstGeom>
          <a:noFill/>
        </p:spPr>
      </p:pic>
      <p:pic>
        <p:nvPicPr>
          <p:cNvPr id="18" name="Picture 7" descr="C:\Users\hahahamj\Desktop\새홀리기\DAPI\U2OSmiR_let7a-MDC1rH2AX-3hr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151257" y="3913850"/>
            <a:ext cx="2160000" cy="2160000"/>
          </a:xfrm>
          <a:prstGeom prst="rect">
            <a:avLst/>
          </a:prstGeom>
          <a:noFill/>
        </p:spPr>
      </p:pic>
      <p:pic>
        <p:nvPicPr>
          <p:cNvPr id="19" name="Picture 5" descr="C:\Users\hahahamj\Desktop\새홀리기\DAPI\U2OSmiR_let7a-MDC1rH2AX-30min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659556" y="3933056"/>
            <a:ext cx="2160000" cy="2160000"/>
          </a:xfrm>
          <a:prstGeom prst="rect">
            <a:avLst/>
          </a:prstGeom>
          <a:noFill/>
        </p:spPr>
      </p:pic>
      <p:pic>
        <p:nvPicPr>
          <p:cNvPr id="21" name="Picture 11" descr="C:\Users\hahahamj\Desktop\새홀리기\DAPI\U2OSmiR_let7a-MDC1rH2AX-1hr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923928" y="3933056"/>
            <a:ext cx="2160000" cy="2160000"/>
          </a:xfrm>
          <a:prstGeom prst="rect">
            <a:avLst/>
          </a:prstGeom>
          <a:noFill/>
        </p:spPr>
      </p:pic>
      <p:sp>
        <p:nvSpPr>
          <p:cNvPr id="30" name="TextBox 29"/>
          <p:cNvSpPr txBox="1"/>
          <p:nvPr/>
        </p:nvSpPr>
        <p:spPr>
          <a:xfrm>
            <a:off x="3059832" y="417438"/>
            <a:ext cx="39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iID3     IR 30 min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33550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22" name="Picture 6" descr="C:\Users\hahahamj\Desktop\새홀리기\rH2AX\U2OSmiR_let7a-MDC1rH2AX-30min-2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47664" y="1557032"/>
            <a:ext cx="2160000" cy="2160000"/>
          </a:xfrm>
          <a:prstGeom prst="rect">
            <a:avLst/>
          </a:prstGeom>
          <a:noFill/>
        </p:spPr>
      </p:pic>
      <p:pic>
        <p:nvPicPr>
          <p:cNvPr id="9230" name="Picture 14" descr="C:\Users\hahahamj\Desktop\새홀리기\rH2AX\U2OSmiR_let7a-MDC1rH2AX-1hr-1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779912" y="1557032"/>
            <a:ext cx="2160000" cy="2160000"/>
          </a:xfrm>
          <a:prstGeom prst="rect">
            <a:avLst/>
          </a:prstGeom>
          <a:noFill/>
        </p:spPr>
      </p:pic>
      <p:pic>
        <p:nvPicPr>
          <p:cNvPr id="9236" name="Picture 20" descr="C:\Users\hahahamj\Desktop\새홀리기\rH2AX\U2OSmiR_let7a-MDC1rH2AX-3hr-1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12160" y="1557032"/>
            <a:ext cx="2160000" cy="2160000"/>
          </a:xfrm>
          <a:prstGeom prst="rect">
            <a:avLst/>
          </a:prstGeom>
          <a:noFill/>
        </p:spPr>
      </p:pic>
      <p:pic>
        <p:nvPicPr>
          <p:cNvPr id="18" name="Picture 2" descr="C:\Users\hahahamj\Desktop\새홀리기\DAPI\U2OSmiR_let7a-MDC1rH2AX-30min-2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530285" y="3789280"/>
            <a:ext cx="2160000" cy="2160000"/>
          </a:xfrm>
          <a:prstGeom prst="rect">
            <a:avLst/>
          </a:prstGeom>
          <a:noFill/>
        </p:spPr>
      </p:pic>
      <p:pic>
        <p:nvPicPr>
          <p:cNvPr id="21" name="Picture 12" descr="C:\Users\hahahamj\Desktop\새홀리기\DAPI\U2OSmiR_let7a-MDC1rH2AX-1hr-1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806227" y="3789040"/>
            <a:ext cx="2160000" cy="2160000"/>
          </a:xfrm>
          <a:prstGeom prst="rect">
            <a:avLst/>
          </a:prstGeom>
          <a:noFill/>
        </p:spPr>
      </p:pic>
      <p:pic>
        <p:nvPicPr>
          <p:cNvPr id="24" name="Picture 8" descr="C:\Users\hahahamj\Desktop\새홀리기\DAPI\U2OSmiR_let7a-MDC1rH2AX-3hr-1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012160" y="3789280"/>
            <a:ext cx="2160000" cy="2160000"/>
          </a:xfrm>
          <a:prstGeom prst="rect">
            <a:avLst/>
          </a:prstGeom>
          <a:noFill/>
        </p:spPr>
      </p:pic>
      <p:sp>
        <p:nvSpPr>
          <p:cNvPr id="26" name="직사각형 25"/>
          <p:cNvSpPr/>
          <p:nvPr/>
        </p:nvSpPr>
        <p:spPr>
          <a:xfrm>
            <a:off x="1403647" y="1484784"/>
            <a:ext cx="2340941" cy="453650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3131840" y="273422"/>
            <a:ext cx="39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iID3     IR 30 min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5887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13.01.09 ID3-rH2AX.mdb\8hr-U2OS-siID1-rH2AX-5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9922" y="254901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F:\13.01.09 ID3-rH2AX.mdb\8hr-U2OS-siID1-rH2AX-6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4298" y="97509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F:\13.01.09 ID3-rH2AX.mdb\8hr-U2OS-siID1-rH2AX-6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2619" y="413083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F:\13.01.09 ID3-rH2AX.mdb\8hr-U2OS-siID1-rH2AX-6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2619" y="25746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F:\13.01.09 ID3-rH2AX.mdb\8hr-U2OS-siID1-rH2AX-1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6549" y="97509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F:\13.01.09 ID3-rH2AX.mdb\8hr-U2OS-siID1-rH2AX-1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6549" y="413083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F:\13.01.09 ID3-rH2AX.mdb\8hr-U2OS-siID1-rH2AX-1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6549" y="25746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F:\13.01.09 ID3-rH2AX.mdb\8hr-U2OS-siID1-rH2AX-2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1778" y="9801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F:\13.01.09 ID3-rH2AX.mdb\8hr-U2OS-siID1-rH2AX-2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1778" y="41382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F:\13.01.09 ID3-rH2AX.mdb\8hr-U2OS-siID1-rH2AX-2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4883" y="25771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F:\13.01.09 ID3-rH2AX.mdb\8hr-U2OS-siID1-rH2AX-3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33" y="97220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F:\13.01.09 ID3-rH2AX.mdb\8hr-U2OS-siID1-rH2AX-3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33" y="41382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2" name="Picture 14" descr="F:\13.01.09 ID3-rH2AX.mdb\8hr-U2OS-siID1-rH2AX-3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33" y="255638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3" name="Picture 15" descr="F:\13.01.09 ID3-rH2AX.mdb\8hr-U2OS-siID1-rH2AX-4_c1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96075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4" name="Picture 16" descr="F:\13.01.09 ID3-rH2AX.mdb\8hr-U2OS-siID1-rH2AX-4_c1+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412910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5" name="Picture 17" descr="F:\13.01.09 ID3-rH2AX.mdb\8hr-U2OS-siID1-rH2AX-4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25449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6" name="Picture 18" descr="F:\13.01.09 ID3-rH2AX.mdb\8hr-U2OS-siID1-rH2AX-5_c1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9922" y="96484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7" name="Picture 19" descr="F:\13.01.09 ID3-rH2AX.mdb\8hr-U2OS-siID1-rH2AX-5_c1+2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9922" y="413083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51520" y="219998"/>
            <a:ext cx="35028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ID3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8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030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F:\13.01.09 ID3-rH2AX.mdb\8hr-U2OS-siID2-rH2AX-2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2" y="270687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F:\13.01.09 ID3-rH2AX.mdb\8hr-U2OS-siID2-rH2AX-3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3826" y="11584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F:\13.01.09 ID3-rH2AX.mdb\8hr-U2OS-siID2-rH2AX-3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3826" y="43120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F:\13.01.09 ID3-rH2AX.mdb\8hr-U2OS-siID2-rH2AX-3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0936" y="27278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F:\13.01.09 ID3-rH2AX.mdb\8hr-U2OS-siID2-rH2AX-4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6730" y="11584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F:\13.01.09 ID3-rH2AX.mdb\8hr-U2OS-siID2-rH2AX-4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5163" y="43120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F:\13.01.09 ID3-rH2AX.mdb\8hr-U2OS-siID2-rH2AX-4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5163" y="27278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F:\13.01.09 ID3-rH2AX.mdb\8hr-U2OS-siID2-rH2AX-5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2995" y="114364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 descr="F:\13.01.09 ID3-rH2AX.mdb\8hr-U2OS-siID2-rH2AX-5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2995" y="43120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F:\13.01.09 ID3-rH2AX.mdb\8hr-U2OS-siID2-rH2AX-5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2995" y="27278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F:\13.01.09 ID3-rH2AX.mdb\8hr-U2OS-siID2-rH2AX-6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6084" y="114364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F:\13.01.09 ID3-rH2AX.mdb\8hr-U2OS-siID2-rH2AX-6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6084" y="43120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6" name="Picture 14" descr="F:\13.01.09 ID3-rH2AX.mdb\8hr-U2OS-siID2-rH2AX-6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6084" y="27278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7" name="Picture 15" descr="F:\13.01.09 ID3-rH2AX.mdb\8hr-U2OS-siID2-rH2AX-1_c1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5485" y="112474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8" name="Picture 16" descr="F:\13.01.09 ID3-rH2AX.mdb\8hr-U2OS-siID2-rH2AX-1_c1+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0558" y="43120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9" name="Picture 17" descr="F:\13.01.09 ID3-rH2AX.mdb\8hr-U2OS-siID2-rH2AX-1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0558" y="27278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0" name="Picture 18" descr="F:\13.01.09 ID3-rH2AX.mdb\8hr-U2OS-siID2-rH2AX-2_c1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82" y="110379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1" name="Picture 19" descr="F:\13.01.09 ID3-rH2AX.mdb\8hr-U2OS-siID2-rH2AX-2_c1+2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2" y="429104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51520" y="219998"/>
            <a:ext cx="35028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ID3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8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0300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F:\13.01.09 ID3-rH2AX.mdb\8hr-U2OS-siID3-rH2AX-5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6805" y="292185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F:\13.01.09 ID3-rH2AX.mdb\8hr-U2OS-siID3-rH2AX-6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37" y="130111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F:\13.01.09 ID3-rH2AX.mdb\8hr-U2OS-siID3-rH2AX-6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37" y="451872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F:\13.01.09 ID3-rH2AX.mdb\8hr-U2OS-siID3-rH2AX-6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37" y="290802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F:\13.01.09 ID3-rH2AX.mdb\8hr-U2OS-siID3-rH2AX-1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36439" y="128719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F:\13.01.09 ID3-rH2AX.mdb\8hr-U2OS-siID3-rH2AX-1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916" y="454719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F:\13.01.09 ID3-rH2AX.mdb\8hr-U2OS-siID3-rH2AX-1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916" y="293667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F:\13.01.09 ID3-rH2AX.mdb\8hr-U2OS-siID3-rH2AX-2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9899" y="128772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10" descr="F:\13.01.09 ID3-rH2AX.mdb\8hr-U2OS-siID3-rH2AX-2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8249" y="454772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7" name="Picture 11" descr="F:\13.01.09 ID3-rH2AX.mdb\8hr-U2OS-siID3-rH2AX-2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8249" y="29372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8" name="Picture 12" descr="F:\13.01.09 ID3-rH2AX.mdb\8hr-U2OS-siID3-rH2AX-3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3191" y="129886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9" name="Picture 13" descr="F:\13.01.09 ID3-rH2AX.mdb\8hr-U2OS-siID3-rH2AX-3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4948" y="452737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0" name="Picture 14" descr="F:\13.01.09 ID3-rH2AX.mdb\8hr-U2OS-siID3-rH2AX-3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4948" y="29432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1" name="Picture 15" descr="F:\13.01.09 ID3-rH2AX.mdb\8hr-U2OS-siID3-rH2AX-4_c1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7527" y="130111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2" name="Picture 16" descr="F:\13.01.09 ID3-rH2AX.mdb\8hr-U2OS-siID3-rH2AX-4_c1+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7527" y="45296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3" name="Picture 17" descr="F:\13.01.09 ID3-rH2AX.mdb\8hr-U2OS-siID3-rH2AX-4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7527" y="295059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4" name="Picture 18" descr="F:\13.01.09 ID3-rH2AX.mdb\8hr-U2OS-siID3-rH2AX-5_c1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6805" y="128927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5" name="Picture 19" descr="F:\13.01.09 ID3-rH2AX.mdb\8hr-U2OS-siID3-rH2AX-5_c1+2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1366" y="45296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51520" y="219998"/>
            <a:ext cx="35028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ID3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8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0300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F:\13.01.09 ID3-rH2AX.mdb\16hr-U2OS-siCTL-rH2AX-5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4634" y="306218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F:\13.01.09 ID3-rH2AX.mdb\16hr-U2OS-siCTL-rH2AX-5_c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4634" y="155679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F:\13.01.09 ID3-rH2AX.mdb\16hr-U2OS-siCTL-rH2AX-6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7105" y="30733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F:\13.01.09 ID3-rH2AX.mdb\16hr-U2OS-siCTL-rH2AX-6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7105" y="156571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F:\13.01.09 ID3-rH2AX.mdb\16hr-U2OS-siCTL-rH2AX-1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3230" y="30781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0" name="Picture 10" descr="F:\13.01.09 ID3-rH2AX.mdb\16hr-U2OS-siCTL-rH2AX-1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3230" y="157271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1" name="Picture 11" descr="F:\13.01.09 ID3-rH2AX.mdb\16hr-U2OS-siCTL-rH2AX-2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9311" y="30803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3" name="Picture 13" descr="F:\13.01.09 ID3-rH2AX.mdb\16hr-U2OS-siCTL-rH2AX-2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9311" y="157271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4" name="Picture 14" descr="F:\13.01.09 ID3-rH2AX.mdb\16hr-U2OS-siCTL-rH2AX-3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0575" y="307908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6" name="Picture 16" descr="F:\13.01.09 ID3-rH2AX.mdb\16hr-U2OS-siCTL-rH2AX-3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0575" y="15736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7" name="Picture 17" descr="F:\13.01.09 ID3-rH2AX.mdb\16hr-U2OS-siCTL-rH2AX-4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911" y="307908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9" name="Picture 19" descr="F:\13.01.09 ID3-rH2AX.mdb\16hr-U2OS-siCTL-rH2AX-4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911" y="15736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633354" y="436602"/>
            <a:ext cx="37226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CTL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16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6065519" y="1424205"/>
            <a:ext cx="1573329" cy="32289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28234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 descr="F:\13.01.09 ID3-rH2AX.mdb\16hr-U2OS-siID1-rH2AX-6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652" y="126485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F:\13.01.09 ID3-rH2AX.mdb\16hr-U2OS-siID1-rH2AX-1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8912" y="278108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F:\13.01.09 ID3-rH2AX.mdb\16hr-U2OS-siID1-rH2AX-1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18912" y="126150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F:\13.01.09 ID3-rH2AX.mdb\16hr-U2OS-siID1-rH2AX-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5861" y="278108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3" name="Picture 9" descr="F:\13.01.09 ID3-rH2AX.mdb\16hr-U2OS-siID1-rH2AX-2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438" y="126485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4" name="Picture 10" descr="F:\13.01.09 ID3-rH2AX.mdb\16hr-U2OS-siID1-rH2AX-3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7453" y="277341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6" name="Picture 12" descr="F:\13.01.09 ID3-rH2AX.mdb\16hr-U2OS-siID1-rH2AX-3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7453" y="126150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7" name="Picture 13" descr="F:\13.01.09 ID3-rH2AX.mdb\16hr-U2OS-siID1-rH2AX-4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3164" y="277341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9" name="Picture 15" descr="F:\13.01.09 ID3-rH2AX.mdb\16hr-U2OS-siID1-rH2AX-4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3164" y="126150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3" name="Picture 19" descr="F:\13.01.09 ID3-rH2AX.mdb\16hr-U2OS-siID1-rH2AX-6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652" y="27767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51520" y="219998"/>
            <a:ext cx="36822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ID3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16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19" descr="C:\Users\hahahamj\Desktop\새홀리기\rH2AX\U2OSmiR_let7a-MDC1rH2AX-3hr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3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623060" y="1278974"/>
            <a:ext cx="1440000" cy="1440000"/>
          </a:xfrm>
          <a:prstGeom prst="rect">
            <a:avLst/>
          </a:prstGeom>
          <a:noFill/>
        </p:spPr>
      </p:pic>
      <p:pic>
        <p:nvPicPr>
          <p:cNvPr id="22" name="Picture 7" descr="C:\Users\hahahamj\Desktop\새홀리기\DAPI\U2OSmiR_let7a-MDC1rH2AX-3hr.jp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1623060" y="2781088"/>
            <a:ext cx="1440000" cy="1440000"/>
          </a:xfrm>
          <a:prstGeom prst="rect">
            <a:avLst/>
          </a:prstGeom>
          <a:noFill/>
        </p:spPr>
      </p:pic>
      <p:sp>
        <p:nvSpPr>
          <p:cNvPr id="2" name="직사각형 1"/>
          <p:cNvSpPr/>
          <p:nvPr/>
        </p:nvSpPr>
        <p:spPr>
          <a:xfrm>
            <a:off x="1591705" y="1124744"/>
            <a:ext cx="1524290" cy="331236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90300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F:\13.01.09 ID3-rH2AX.mdb\16hr-U2OS-siID2-rH2AX-4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5547" y="11641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F:\13.01.09 ID3-rH2AX.mdb\16hr-U2OS-siID2-rH2AX-4_c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3488" y="277672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F:\13.01.09 ID3-rH2AX.mdb\16hr-U2OS-siID2-rH2AX-5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3379" y="11674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5" name="Picture 7" descr="F:\13.01.09 ID3-rH2AX.mdb\16hr-U2OS-siID2-rH2AX-5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3379" y="277336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6" name="Picture 8" descr="F:\13.01.09 ID3-rH2AX.mdb\16hr-U2OS-siID2-rH2AX-6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1211" y="11674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8" name="Picture 10" descr="F:\13.01.09 ID3-rH2AX.mdb\16hr-U2OS-siID2-rH2AX-6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1211" y="277336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9" name="Picture 11" descr="F:\13.01.09 ID3-rH2AX.mdb\16hr-U2OS-siID2-rH2AX-1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8276" y="11641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1" name="Picture 13" descr="F:\13.01.09 ID3-rH2AX.mdb\16hr-U2OS-siID2-rH2AX-1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8276" y="277336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2" name="Picture 14" descr="F:\13.01.09 ID3-rH2AX.mdb\16hr-U2OS-siID2-rH2AX-2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2919" y="117193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4" name="Picture 16" descr="F:\13.01.09 ID3-rH2AX.mdb\16hr-U2OS-siID2-rH2AX-2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2919" y="277781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5" name="Picture 17" descr="F:\13.01.09 ID3-rH2AX.mdb\16hr-U2OS-siID2-rH2AX-3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33" y="115502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7" name="Picture 19" descr="F:\13.01.09 ID3-rH2AX.mdb\16hr-U2OS-siID2-rH2AX-3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80" y="280334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451806" y="332656"/>
            <a:ext cx="36822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ID3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16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0300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F:\13.01.09 ID3-rH2AX.mdb\16hr-U2OS-siID3-rH2AX-5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9325" y="270756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F:\13.01.09 ID3-rH2AX.mdb\16hr-U2OS-siID3-rH2AX-6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953" y="111408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7" name="Picture 5" descr="F:\13.01.09 ID3-rH2AX.mdb\16hr-U2OS-siID3-rH2AX-6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953" y="272225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8" name="Picture 6" descr="F:\13.01.09 ID3-rH2AX.mdb\16hr-U2OS-siID3-rH2AX-1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3476" y="113729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F:\13.01.09 ID3-rH2AX.mdb\16hr-U2OS-siID3-rH2AX-1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4438" y="272265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1" name="Picture 9" descr="F:\13.01.09 ID3-rH2AX.mdb\16hr-U2OS-siID3-rH2AX-2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2826" y="112465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3" name="Picture 11" descr="F:\13.01.09 ID3-rH2AX.mdb\16hr-U2OS-siID3-rH2AX-2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7136" y="269926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4" name="Picture 12" descr="F:\13.01.09 ID3-rH2AX.mdb\16hr-U2OS-siID3-rH2AX-3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4304" y="112465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6" name="Picture 14" descr="F:\13.01.09 ID3-rH2AX.mdb\16hr-U2OS-siID3-rH2AX-3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4304" y="269926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7" name="Picture 15" descr="F:\13.01.09 ID3-rH2AX.mdb\16hr-U2OS-siID3-rH2AX-4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3258" y="112153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9" name="Picture 17" descr="F:\13.01.09 ID3-rH2AX.mdb\16hr-U2OS-siID3-rH2AX-4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0869" y="268901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10" name="Picture 18" descr="F:\13.01.09 ID3-rH2AX.mdb\16hr-U2OS-siID3-rH2AX-5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9325" y="115089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94764" y="263253"/>
            <a:ext cx="3645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ID3 </a:t>
            </a:r>
            <a:r>
              <a:rPr lang="en-US" altLang="ko-KR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Gy-16 hr-rH2AX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30891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3973500" y="476672"/>
            <a:ext cx="27587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La- 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    UT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3581636" y="1799860"/>
            <a:ext cx="2574540" cy="472548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4" name="Picture 3" descr="C:\Users\hahahamj\Desktop\새홀리기\rH2AX\U2OSsiCTL-MDC1rH2AX-0hr0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79912" y="1988840"/>
            <a:ext cx="2160000" cy="2160000"/>
          </a:xfrm>
          <a:prstGeom prst="rect">
            <a:avLst/>
          </a:prstGeom>
          <a:noFill/>
        </p:spPr>
      </p:pic>
      <p:pic>
        <p:nvPicPr>
          <p:cNvPr id="15" name="Picture 5" descr="C:\Users\hahahamj\Desktop\새홀리기\DAPI\U2OSsiCTL-MDC1rH2AX-0hr0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813284" y="4221088"/>
            <a:ext cx="2160000" cy="21600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594993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rgbClr val="C00000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6</TotalTime>
  <Words>92</Words>
  <Application>Microsoft Office PowerPoint</Application>
  <PresentationFormat>화면 슬라이드 쇼(4:3)</PresentationFormat>
  <Paragraphs>33</Paragraphs>
  <Slides>16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6</vt:i4>
      </vt:variant>
    </vt:vector>
  </HeadingPairs>
  <TitlesOfParts>
    <vt:vector size="19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hahamj</dc:creator>
  <cp:lastModifiedBy>chosun</cp:lastModifiedBy>
  <cp:revision>24</cp:revision>
  <cp:lastPrinted>2013-01-14T01:34:09Z</cp:lastPrinted>
  <dcterms:created xsi:type="dcterms:W3CDTF">2013-01-12T06:05:27Z</dcterms:created>
  <dcterms:modified xsi:type="dcterms:W3CDTF">2018-05-02T13:33:40Z</dcterms:modified>
</cp:coreProperties>
</file>